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0AF0151-9361-4123-8B5E-D38324843CE7}">
          <p14:sldIdLst/>
        </p14:section>
        <p14:section name="无标题节" id="{031C27FF-B83F-4552-8E20-7CF25D858727}">
          <p14:sldIdLst>
            <p14:sldId id="26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zhishu2009@163.com" initials="f" lastIdx="10" clrIdx="0">
    <p:extLst>
      <p:ext uri="{19B8F6BF-5375-455C-9EA6-DF929625EA0E}">
        <p15:presenceInfo xmlns:p15="http://schemas.microsoft.com/office/powerpoint/2012/main" userId="696e086e05cbe20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84F9E"/>
    <a:srgbClr val="595959"/>
    <a:srgbClr val="6E4D83"/>
    <a:srgbClr val="F2A2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91" autoAdjust="0"/>
    <p:restoredTop sz="93826" autoAdjust="0"/>
  </p:normalViewPr>
  <p:slideViewPr>
    <p:cSldViewPr snapToGrid="0" showGuides="1">
      <p:cViewPr varScale="1">
        <p:scale>
          <a:sx n="44" d="100"/>
          <a:sy n="44" d="100"/>
        </p:scale>
        <p:origin x="2116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35770;&#25991;\SD1\20191128%201129MADS56%20sd1%20gnp1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249739208601221E-2"/>
          <c:y val="4.8096336835971379E-2"/>
          <c:w val="0.92981510003710044"/>
          <c:h val="0.699318036448781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M$15</c:f>
              <c:strCache>
                <c:ptCount val="1"/>
                <c:pt idx="0">
                  <c:v>SD1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M$31:$M$42</c:f>
                <c:numCache>
                  <c:formatCode>General</c:formatCode>
                  <c:ptCount val="12"/>
                  <c:pt idx="0">
                    <c:v>0.19098445046193149</c:v>
                  </c:pt>
                  <c:pt idx="1">
                    <c:v>0.57543246567467454</c:v>
                  </c:pt>
                  <c:pt idx="2">
                    <c:v>0.10260064658110635</c:v>
                  </c:pt>
                  <c:pt idx="3">
                    <c:v>1.8918760496840537E-2</c:v>
                  </c:pt>
                  <c:pt idx="4">
                    <c:v>7.610074625696385E-3</c:v>
                  </c:pt>
                  <c:pt idx="5">
                    <c:v>1.3417603320889831E-3</c:v>
                  </c:pt>
                  <c:pt idx="6">
                    <c:v>1.537158408390738E-2</c:v>
                  </c:pt>
                  <c:pt idx="7">
                    <c:v>1.3398140798380853E-3</c:v>
                  </c:pt>
                  <c:pt idx="8">
                    <c:v>0.24503450716267211</c:v>
                  </c:pt>
                  <c:pt idx="9">
                    <c:v>2.5360182469669292E-3</c:v>
                  </c:pt>
                  <c:pt idx="10">
                    <c:v>1.3884008410719583E-3</c:v>
                  </c:pt>
                  <c:pt idx="11">
                    <c:v>0.11171874650825102</c:v>
                  </c:pt>
                </c:numCache>
              </c:numRef>
            </c:plus>
            <c:minus>
              <c:numRef>
                <c:f>Sheet2!$M$31:$M$42</c:f>
                <c:numCache>
                  <c:formatCode>General</c:formatCode>
                  <c:ptCount val="12"/>
                  <c:pt idx="0">
                    <c:v>0.19098445046193149</c:v>
                  </c:pt>
                  <c:pt idx="1">
                    <c:v>0.57543246567467454</c:v>
                  </c:pt>
                  <c:pt idx="2">
                    <c:v>0.10260064658110635</c:v>
                  </c:pt>
                  <c:pt idx="3">
                    <c:v>1.8918760496840537E-2</c:v>
                  </c:pt>
                  <c:pt idx="4">
                    <c:v>7.610074625696385E-3</c:v>
                  </c:pt>
                  <c:pt idx="5">
                    <c:v>1.3417603320889831E-3</c:v>
                  </c:pt>
                  <c:pt idx="6">
                    <c:v>1.537158408390738E-2</c:v>
                  </c:pt>
                  <c:pt idx="7">
                    <c:v>1.3398140798380853E-3</c:v>
                  </c:pt>
                  <c:pt idx="8">
                    <c:v>0.24503450716267211</c:v>
                  </c:pt>
                  <c:pt idx="9">
                    <c:v>2.5360182469669292E-3</c:v>
                  </c:pt>
                  <c:pt idx="10">
                    <c:v>1.3884008410719583E-3</c:v>
                  </c:pt>
                  <c:pt idx="11">
                    <c:v>0.11171874650825102</c:v>
                  </c:pt>
                </c:numCache>
              </c:numRef>
            </c:minus>
            <c:spPr>
              <a:solidFill>
                <a:schemeClr val="accent1"/>
              </a:solidFill>
              <a:ln w="19050">
                <a:solidFill>
                  <a:schemeClr val="tx1"/>
                </a:solidFill>
              </a:ln>
              <a:effectLst/>
            </c:spPr>
          </c:errBars>
          <c:cat>
            <c:strRef>
              <c:f>Sheet2!$L$16:$L$27</c:f>
              <c:strCache>
                <c:ptCount val="12"/>
                <c:pt idx="0">
                  <c:v>ml</c:v>
                </c:pt>
                <c:pt idx="1">
                  <c:v>yl</c:v>
                </c:pt>
                <c:pt idx="2">
                  <c:v>yl sh</c:v>
                </c:pt>
                <c:pt idx="3">
                  <c:v>pbp</c:v>
                </c:pt>
                <c:pt idx="4">
                  <c:v>sbp</c:v>
                </c:pt>
                <c:pt idx="5">
                  <c:v>1-4cm pl</c:v>
                </c:pt>
                <c:pt idx="6">
                  <c:v>4-8cm pl</c:v>
                </c:pt>
                <c:pt idx="7">
                  <c:v>8-12cm pl</c:v>
                </c:pt>
                <c:pt idx="8">
                  <c:v>12-16cm pl</c:v>
                </c:pt>
                <c:pt idx="9">
                  <c:v>16-20cm pl</c:v>
                </c:pt>
                <c:pt idx="10">
                  <c:v>el</c:v>
                </c:pt>
                <c:pt idx="11">
                  <c:v>root</c:v>
                </c:pt>
              </c:strCache>
            </c:strRef>
          </c:cat>
          <c:val>
            <c:numRef>
              <c:f>Sheet2!$M$16:$M$27</c:f>
              <c:numCache>
                <c:formatCode>General</c:formatCode>
                <c:ptCount val="12"/>
                <c:pt idx="0">
                  <c:v>1.2150261191250529</c:v>
                </c:pt>
                <c:pt idx="1">
                  <c:v>4.2982459880091746</c:v>
                </c:pt>
                <c:pt idx="2">
                  <c:v>0.66715317045298506</c:v>
                </c:pt>
                <c:pt idx="3">
                  <c:v>9.2094286585402418E-2</c:v>
                </c:pt>
                <c:pt idx="4">
                  <c:v>6.2817783757146653E-2</c:v>
                </c:pt>
                <c:pt idx="5">
                  <c:v>3.1134278108448678E-2</c:v>
                </c:pt>
                <c:pt idx="6">
                  <c:v>4.0569722486871254E-2</c:v>
                </c:pt>
                <c:pt idx="7">
                  <c:v>7.6224909752675291E-3</c:v>
                </c:pt>
                <c:pt idx="8">
                  <c:v>0.32243316828192081</c:v>
                </c:pt>
                <c:pt idx="9">
                  <c:v>1.0012994190584995E-2</c:v>
                </c:pt>
                <c:pt idx="10">
                  <c:v>8.0040987618738582E-2</c:v>
                </c:pt>
                <c:pt idx="11">
                  <c:v>1.40562309573735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C5F-45F4-B59B-2CCA47B9FDC7}"/>
            </c:ext>
          </c:extLst>
        </c:ser>
        <c:ser>
          <c:idx val="1"/>
          <c:order val="1"/>
          <c:tx>
            <c:strRef>
              <c:f>Sheet2!$N$15</c:f>
              <c:strCache>
                <c:ptCount val="1"/>
                <c:pt idx="0">
                  <c:v>GNP1</c:v>
                </c:pt>
              </c:strCache>
            </c:strRef>
          </c:tx>
          <c:spPr>
            <a:solidFill>
              <a:schemeClr val="accent1">
                <a:lumMod val="20000"/>
                <a:lumOff val="8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31:$N$42</c:f>
                <c:numCache>
                  <c:formatCode>General</c:formatCode>
                  <c:ptCount val="12"/>
                  <c:pt idx="0">
                    <c:v>0.10054618020285354</c:v>
                  </c:pt>
                  <c:pt idx="1">
                    <c:v>4.3815500543706906E-2</c:v>
                  </c:pt>
                  <c:pt idx="2">
                    <c:v>7.7444698066542417E-2</c:v>
                  </c:pt>
                  <c:pt idx="3">
                    <c:v>2.5546413949648988E-2</c:v>
                  </c:pt>
                  <c:pt idx="4">
                    <c:v>7.0762267807492604E-2</c:v>
                  </c:pt>
                  <c:pt idx="5">
                    <c:v>7.97733415597673E-2</c:v>
                  </c:pt>
                  <c:pt idx="6">
                    <c:v>5.71097621224506E-2</c:v>
                  </c:pt>
                  <c:pt idx="7">
                    <c:v>1.12049174785107E-2</c:v>
                  </c:pt>
                  <c:pt idx="8">
                    <c:v>1.5554004218720901E-2</c:v>
                  </c:pt>
                  <c:pt idx="9">
                    <c:v>8.8964560309470597E-3</c:v>
                  </c:pt>
                  <c:pt idx="10">
                    <c:v>1.289580299973951E-2</c:v>
                  </c:pt>
                  <c:pt idx="11">
                    <c:v>0.10771080153823601</c:v>
                  </c:pt>
                </c:numCache>
              </c:numRef>
            </c:plus>
            <c:minus>
              <c:numRef>
                <c:f>Sheet2!$N$31:$N$42</c:f>
                <c:numCache>
                  <c:formatCode>General</c:formatCode>
                  <c:ptCount val="12"/>
                  <c:pt idx="0">
                    <c:v>0.10054618020285354</c:v>
                  </c:pt>
                  <c:pt idx="1">
                    <c:v>4.3815500543706906E-2</c:v>
                  </c:pt>
                  <c:pt idx="2">
                    <c:v>7.7444698066542417E-2</c:v>
                  </c:pt>
                  <c:pt idx="3">
                    <c:v>2.5546413949648988E-2</c:v>
                  </c:pt>
                  <c:pt idx="4">
                    <c:v>7.0762267807492604E-2</c:v>
                  </c:pt>
                  <c:pt idx="5">
                    <c:v>7.97733415597673E-2</c:v>
                  </c:pt>
                  <c:pt idx="6">
                    <c:v>5.71097621224506E-2</c:v>
                  </c:pt>
                  <c:pt idx="7">
                    <c:v>1.12049174785107E-2</c:v>
                  </c:pt>
                  <c:pt idx="8">
                    <c:v>1.5554004218720901E-2</c:v>
                  </c:pt>
                  <c:pt idx="9">
                    <c:v>8.8964560309470597E-3</c:v>
                  </c:pt>
                  <c:pt idx="10">
                    <c:v>1.289580299973951E-2</c:v>
                  </c:pt>
                  <c:pt idx="11">
                    <c:v>0.10771080153823601</c:v>
                  </c:pt>
                </c:numCache>
              </c:numRef>
            </c:minus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</c:errBars>
          <c:cat>
            <c:strRef>
              <c:f>Sheet2!$L$16:$L$27</c:f>
              <c:strCache>
                <c:ptCount val="12"/>
                <c:pt idx="0">
                  <c:v>ml</c:v>
                </c:pt>
                <c:pt idx="1">
                  <c:v>yl</c:v>
                </c:pt>
                <c:pt idx="2">
                  <c:v>yl sh</c:v>
                </c:pt>
                <c:pt idx="3">
                  <c:v>pbp</c:v>
                </c:pt>
                <c:pt idx="4">
                  <c:v>sbp</c:v>
                </c:pt>
                <c:pt idx="5">
                  <c:v>1-4cm pl</c:v>
                </c:pt>
                <c:pt idx="6">
                  <c:v>4-8cm pl</c:v>
                </c:pt>
                <c:pt idx="7">
                  <c:v>8-12cm pl</c:v>
                </c:pt>
                <c:pt idx="8">
                  <c:v>12-16cm pl</c:v>
                </c:pt>
                <c:pt idx="9">
                  <c:v>16-20cm pl</c:v>
                </c:pt>
                <c:pt idx="10">
                  <c:v>el</c:v>
                </c:pt>
                <c:pt idx="11">
                  <c:v>root</c:v>
                </c:pt>
              </c:strCache>
            </c:strRef>
          </c:cat>
          <c:val>
            <c:numRef>
              <c:f>Sheet2!$N$16:$N$27</c:f>
              <c:numCache>
                <c:formatCode>General</c:formatCode>
                <c:ptCount val="12"/>
                <c:pt idx="0">
                  <c:v>1.1401171761158804</c:v>
                </c:pt>
                <c:pt idx="1">
                  <c:v>0.85966204147879122</c:v>
                </c:pt>
                <c:pt idx="2">
                  <c:v>0.60245088264328617</c:v>
                </c:pt>
                <c:pt idx="3">
                  <c:v>0.27350250730253428</c:v>
                </c:pt>
                <c:pt idx="4">
                  <c:v>0.59841560009269046</c:v>
                </c:pt>
                <c:pt idx="5">
                  <c:v>9.9367693558263179E-2</c:v>
                </c:pt>
                <c:pt idx="6">
                  <c:v>0.17403560935355986</c:v>
                </c:pt>
                <c:pt idx="7">
                  <c:v>5.5180387087815697E-2</c:v>
                </c:pt>
                <c:pt idx="8">
                  <c:v>0.32346474971594807</c:v>
                </c:pt>
                <c:pt idx="9">
                  <c:v>7.7296186332161565E-2</c:v>
                </c:pt>
                <c:pt idx="10">
                  <c:v>8.0278786727885229E-2</c:v>
                </c:pt>
                <c:pt idx="11">
                  <c:v>0.261444812456065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C5F-45F4-B59B-2CCA47B9FD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564743624"/>
        <c:axId val="1"/>
      </c:barChart>
      <c:catAx>
        <c:axId val="564743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64743624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79493919510061239"/>
          <c:y val="1.9096675415573052E-2"/>
          <c:w val="0.18980664916885392"/>
          <c:h val="7.3450714494021588E-2"/>
        </c:manualLayout>
      </c:layout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FED27-533D-4C2F-96A3-38C026D66261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FFB7C-A235-4241-9546-2785CD185C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313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5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9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67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54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8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67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2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91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8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63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1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AD101C48-9108-4971-8079-72DF72D05A35}"/>
              </a:ext>
            </a:extLst>
          </p:cNvPr>
          <p:cNvGrpSpPr/>
          <p:nvPr/>
        </p:nvGrpSpPr>
        <p:grpSpPr>
          <a:xfrm>
            <a:off x="1117055" y="1892253"/>
            <a:ext cx="4187515" cy="2635918"/>
            <a:chOff x="-58602" y="5448253"/>
            <a:chExt cx="4187515" cy="2635918"/>
          </a:xfrm>
        </p:grpSpPr>
        <p:graphicFrame>
          <p:nvGraphicFramePr>
            <p:cNvPr id="215" name="图表 214">
              <a:extLst>
                <a:ext uri="{FF2B5EF4-FFF2-40B4-BE49-F238E27FC236}">
                  <a16:creationId xmlns:a16="http://schemas.microsoft.com/office/drawing/2014/main" id="{86D82CEF-093B-44A5-B1A4-D88EE1D2E86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59456329"/>
                </p:ext>
              </p:extLst>
            </p:nvPr>
          </p:nvGraphicFramePr>
          <p:xfrm>
            <a:off x="135181" y="5448253"/>
            <a:ext cx="3951434" cy="263591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08" name="文本框 407">
              <a:extLst>
                <a:ext uri="{FF2B5EF4-FFF2-40B4-BE49-F238E27FC236}">
                  <a16:creationId xmlns:a16="http://schemas.microsoft.com/office/drawing/2014/main" id="{033E87D6-A2B6-4D2B-AB70-F969ADDCC27E}"/>
                </a:ext>
              </a:extLst>
            </p:cNvPr>
            <p:cNvSpPr txBox="1"/>
            <p:nvPr/>
          </p:nvSpPr>
          <p:spPr>
            <a:xfrm rot="10800000">
              <a:off x="-58602" y="5882663"/>
              <a:ext cx="323165" cy="109617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</a:t>
              </a:r>
              <a:endParaRPr lang="zh-CN" altLang="en-US" sz="900" i="1" dirty="0"/>
            </a:p>
          </p:txBody>
        </p:sp>
        <p:sp>
          <p:nvSpPr>
            <p:cNvPr id="410" name="文本框 409">
              <a:extLst>
                <a:ext uri="{FF2B5EF4-FFF2-40B4-BE49-F238E27FC236}">
                  <a16:creationId xmlns:a16="http://schemas.microsoft.com/office/drawing/2014/main" id="{E57AE1EF-D3AB-4DF5-B4C4-45B48F870A5C}"/>
                </a:ext>
              </a:extLst>
            </p:cNvPr>
            <p:cNvSpPr txBox="1"/>
            <p:nvPr/>
          </p:nvSpPr>
          <p:spPr>
            <a:xfrm>
              <a:off x="734047" y="6978833"/>
              <a:ext cx="325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  <p:sp>
          <p:nvSpPr>
            <p:cNvPr id="411" name="文本框 410">
              <a:extLst>
                <a:ext uri="{FF2B5EF4-FFF2-40B4-BE49-F238E27FC236}">
                  <a16:creationId xmlns:a16="http://schemas.microsoft.com/office/drawing/2014/main" id="{204EF35A-C54A-4154-ADAE-A61E9279D0D4}"/>
                </a:ext>
              </a:extLst>
            </p:cNvPr>
            <p:cNvSpPr txBox="1"/>
            <p:nvPr/>
          </p:nvSpPr>
          <p:spPr>
            <a:xfrm>
              <a:off x="1340915" y="7163851"/>
              <a:ext cx="325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  <p:sp>
          <p:nvSpPr>
            <p:cNvPr id="412" name="文本框 411">
              <a:extLst>
                <a:ext uri="{FF2B5EF4-FFF2-40B4-BE49-F238E27FC236}">
                  <a16:creationId xmlns:a16="http://schemas.microsoft.com/office/drawing/2014/main" id="{EEA37D84-54A6-43E0-B4A7-D62E7CB56019}"/>
                </a:ext>
              </a:extLst>
            </p:cNvPr>
            <p:cNvSpPr txBox="1"/>
            <p:nvPr/>
          </p:nvSpPr>
          <p:spPr>
            <a:xfrm>
              <a:off x="1646009" y="7048435"/>
              <a:ext cx="325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  <p:sp>
          <p:nvSpPr>
            <p:cNvPr id="413" name="文本框 412">
              <a:extLst>
                <a:ext uri="{FF2B5EF4-FFF2-40B4-BE49-F238E27FC236}">
                  <a16:creationId xmlns:a16="http://schemas.microsoft.com/office/drawing/2014/main" id="{A04B9CE2-6C07-48CF-97CF-6EA379891A52}"/>
                </a:ext>
              </a:extLst>
            </p:cNvPr>
            <p:cNvSpPr txBox="1"/>
            <p:nvPr/>
          </p:nvSpPr>
          <p:spPr>
            <a:xfrm>
              <a:off x="1948922" y="7191222"/>
              <a:ext cx="325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  <p:sp>
          <p:nvSpPr>
            <p:cNvPr id="414" name="文本框 413">
              <a:extLst>
                <a:ext uri="{FF2B5EF4-FFF2-40B4-BE49-F238E27FC236}">
                  <a16:creationId xmlns:a16="http://schemas.microsoft.com/office/drawing/2014/main" id="{A1F4B561-78FB-447A-8F58-1001B0CB8E15}"/>
                </a:ext>
              </a:extLst>
            </p:cNvPr>
            <p:cNvSpPr txBox="1"/>
            <p:nvPr/>
          </p:nvSpPr>
          <p:spPr>
            <a:xfrm>
              <a:off x="2258631" y="7191222"/>
              <a:ext cx="325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  <p:sp>
          <p:nvSpPr>
            <p:cNvPr id="415" name="文本框 414">
              <a:extLst>
                <a:ext uri="{FF2B5EF4-FFF2-40B4-BE49-F238E27FC236}">
                  <a16:creationId xmlns:a16="http://schemas.microsoft.com/office/drawing/2014/main" id="{7AAA9E1F-F2F2-457A-868A-0148501C7BA8}"/>
                </a:ext>
              </a:extLst>
            </p:cNvPr>
            <p:cNvSpPr txBox="1"/>
            <p:nvPr/>
          </p:nvSpPr>
          <p:spPr>
            <a:xfrm>
              <a:off x="3803514" y="7121193"/>
              <a:ext cx="325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  <p:sp>
          <p:nvSpPr>
            <p:cNvPr id="416" name="文本框 415">
              <a:extLst>
                <a:ext uri="{FF2B5EF4-FFF2-40B4-BE49-F238E27FC236}">
                  <a16:creationId xmlns:a16="http://schemas.microsoft.com/office/drawing/2014/main" id="{4A868847-E563-4E6F-A098-D25E9D25769A}"/>
                </a:ext>
              </a:extLst>
            </p:cNvPr>
            <p:cNvSpPr txBox="1"/>
            <p:nvPr/>
          </p:nvSpPr>
          <p:spPr>
            <a:xfrm>
              <a:off x="3181454" y="7236018"/>
              <a:ext cx="325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  <p:sp>
          <p:nvSpPr>
            <p:cNvPr id="422" name="文本框 421">
              <a:extLst>
                <a:ext uri="{FF2B5EF4-FFF2-40B4-BE49-F238E27FC236}">
                  <a16:creationId xmlns:a16="http://schemas.microsoft.com/office/drawing/2014/main" id="{50028C52-1CD9-4D3E-8579-8A217E93ECB9}"/>
                </a:ext>
              </a:extLst>
            </p:cNvPr>
            <p:cNvSpPr txBox="1"/>
            <p:nvPr/>
          </p:nvSpPr>
          <p:spPr>
            <a:xfrm>
              <a:off x="2561544" y="7240739"/>
              <a:ext cx="3253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900" b="1" dirty="0"/>
                <a:t>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66738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63</TotalTime>
  <Words>10</Words>
  <Application>Microsoft Office PowerPoint</Application>
  <PresentationFormat>A4 纸张(210x297 毫米)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丽春 曹</dc:creator>
  <cp:lastModifiedBy>fengzhishu2009@163.com</cp:lastModifiedBy>
  <cp:revision>644</cp:revision>
  <dcterms:created xsi:type="dcterms:W3CDTF">2019-11-29T08:26:13Z</dcterms:created>
  <dcterms:modified xsi:type="dcterms:W3CDTF">2021-07-01T09:03:43Z</dcterms:modified>
</cp:coreProperties>
</file>